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6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5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11C594-7E18-4DA5-8CD2-2E941F0DFDE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1C74A51-FF0F-4FB0-9F4E-208C3F8F1F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B1F880-67B2-4A90-BB17-B23AD35E95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8B1A4-493D-49CD-8F62-BBE44262B8F4}" type="datetimeFigureOut">
              <a:rPr lang="en-CA" smtClean="0"/>
              <a:t>2019-05-0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8C52FF-83C2-4246-83C3-4398BE8E3B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1B905A-9382-4AF3-8990-3F19B805C6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09A1C-268D-47EC-B99F-1F0B709A648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51988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545358-5985-4037-8368-007C03F2E4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77C7D9-63F3-4F2D-89A8-D8B48E171F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8ED341-A690-44C8-AC94-A42EAFA7D3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8B1A4-493D-49CD-8F62-BBE44262B8F4}" type="datetimeFigureOut">
              <a:rPr lang="en-CA" smtClean="0"/>
              <a:t>2019-05-0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A1A9EE-E5E0-4FFB-9283-580274A810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EFFF29-9F27-4DB5-9F69-CAB5073FC2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09A1C-268D-47EC-B99F-1F0B709A648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232101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AB080DD-7D53-460F-AB1F-517810E3FCC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5A1D13-3A18-4BC1-9AB5-970BE2B946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62EFC7-20EC-4F55-ABEB-748DB6878D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8B1A4-493D-49CD-8F62-BBE44262B8F4}" type="datetimeFigureOut">
              <a:rPr lang="en-CA" smtClean="0"/>
              <a:t>2019-05-0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EC6106-BD6A-4D24-9E76-BBAF6805FC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14D68B-DB99-4656-966A-5C0D5038CD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09A1C-268D-47EC-B99F-1F0B709A648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934922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5E2EDA-2135-4A7A-9B62-737D39C14D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26182C-8BB8-4727-86B8-AFFEC269E0F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5A5E01-EE3A-4192-B56B-34109E2D99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8B1A4-493D-49CD-8F62-BBE44262B8F4}" type="datetimeFigureOut">
              <a:rPr lang="en-CA" smtClean="0"/>
              <a:t>2019-05-0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DC4502-E1C7-4A83-A257-5A3215F8B5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3F7C1D-AFFA-4E07-A496-B6DF8672D3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09A1C-268D-47EC-B99F-1F0B709A648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195756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DAB7A4-5FF7-4B1A-994D-3A27E22C41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2E3343-4DC3-432A-857A-92F48D2C21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3DEA29-A9D5-4B0C-880C-6D48FE559F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8B1A4-493D-49CD-8F62-BBE44262B8F4}" type="datetimeFigureOut">
              <a:rPr lang="en-CA" smtClean="0"/>
              <a:t>2019-05-0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AD10B7-00C6-44B5-A65F-16B027A198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840043-8470-401F-898D-E7595E1A6A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09A1C-268D-47EC-B99F-1F0B709A648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9913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4FD807-9017-46B8-B6E3-EDAB9894A9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D7E2EF-A076-4568-ABCC-E2CC8DDD38F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F914E52-9A55-41D2-9D36-75DE189FE9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B0F5F7D-312F-4748-A322-FED2509A30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8B1A4-493D-49CD-8F62-BBE44262B8F4}" type="datetimeFigureOut">
              <a:rPr lang="en-CA" smtClean="0"/>
              <a:t>2019-05-0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E67DAF-63A0-4D66-9CAF-6AC13941D4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523356-F232-408F-AA7D-C2E720EA55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09A1C-268D-47EC-B99F-1F0B709A648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280061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2B7CAD-238D-4A54-A97D-D126343044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2D37DA-3925-4281-94B1-2B65515051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B98127-640E-4A6A-99B9-055D103260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9A57E7C-2AD6-44EE-B59D-6A0D6A7DD8A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E298676-AF71-45A4-81DE-8751C7C6FC3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CEDAEE0-9DD3-44A0-99E8-DADF204191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8B1A4-493D-49CD-8F62-BBE44262B8F4}" type="datetimeFigureOut">
              <a:rPr lang="en-CA" smtClean="0"/>
              <a:t>2019-05-01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06255AC-11FE-445C-ACED-C627C8AC7C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12387ED-596A-4DC4-AE53-56D9696B8C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09A1C-268D-47EC-B99F-1F0B709A648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60551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07DD81-A76E-4349-9E41-89D556D9D6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625B6F8-F690-4869-A2A9-2456BF56C2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8B1A4-493D-49CD-8F62-BBE44262B8F4}" type="datetimeFigureOut">
              <a:rPr lang="en-CA" smtClean="0"/>
              <a:t>2019-05-01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FF8E8E8-B2B0-45C8-8B34-C2B6B73FEB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1092929-780A-4305-B32C-AB2955F828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09A1C-268D-47EC-B99F-1F0B709A648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855084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D620EC7-4089-4204-8956-A16C59486E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8B1A4-493D-49CD-8F62-BBE44262B8F4}" type="datetimeFigureOut">
              <a:rPr lang="en-CA" smtClean="0"/>
              <a:t>2019-05-01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6383BE6-24D3-4663-9BE6-B299817F54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B9B426B-186F-4142-A14A-A07BCDA674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09A1C-268D-47EC-B99F-1F0B709A648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058047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63069D-444D-44C3-9D22-249B27EF39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03A3F8-A538-4AF9-BBA3-CD503ADB54C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C3EE6EB-BAE2-413E-809E-C22689D2D2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49EAF1-298A-4FFD-A2EF-E8AB53D888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8B1A4-493D-49CD-8F62-BBE44262B8F4}" type="datetimeFigureOut">
              <a:rPr lang="en-CA" smtClean="0"/>
              <a:t>2019-05-0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48A70D-0834-412A-B202-CD7ADB1C28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492909-1F99-4129-B56E-B4CDE1B1FE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09A1C-268D-47EC-B99F-1F0B709A648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066463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C4D3F3-B891-4E37-B5A3-18618D28EC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BAE7ACB-20D5-4AE1-82F3-EE13A02E46B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C336BF-AF20-4ED5-921E-233BE2C413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114774-E1A1-4BC9-BB02-6CD6DC2F1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8B1A4-493D-49CD-8F62-BBE44262B8F4}" type="datetimeFigureOut">
              <a:rPr lang="en-CA" smtClean="0"/>
              <a:t>2019-05-0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2081B9-1625-489E-83B7-A67FD03FB2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090F7F-BE17-445D-AAFB-7E11D7F974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09A1C-268D-47EC-B99F-1F0B709A648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697782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B8DBEB0-0354-4D41-88B3-2E47BCC0E6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2BC8CB-28F4-4760-9499-B07ECBA7F4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AE23D1-D738-4092-9FCF-C9E39AAA324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C8B1A4-493D-49CD-8F62-BBE44262B8F4}" type="datetimeFigureOut">
              <a:rPr lang="en-CA" smtClean="0"/>
              <a:t>2019-05-0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C2C0BC-FF94-417B-9233-A27E791601D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596F89-5E39-4274-A6EE-4D6639C72A2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F09A1C-268D-47EC-B99F-1F0B709A648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03812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6FDBB3C2-2A7F-4E3D-8544-0410259C18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CA"/>
          </a:p>
        </p:txBody>
      </p:sp>
      <p:pic>
        <p:nvPicPr>
          <p:cNvPr id="2049" name="Picture 10">
            <a:extLst>
              <a:ext uri="{FF2B5EF4-FFF2-40B4-BE49-F238E27FC236}">
                <a16:creationId xmlns:a16="http://schemas.microsoft.com/office/drawing/2014/main" id="{430113A3-8F6B-4BBE-9BF3-F3453FFCD0B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4834" y="921026"/>
            <a:ext cx="5734050" cy="32194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A4E80C9E-E110-4D35-8304-244551518791}"/>
              </a:ext>
            </a:extLst>
          </p:cNvPr>
          <p:cNvSpPr/>
          <p:nvPr/>
        </p:nvSpPr>
        <p:spPr>
          <a:xfrm>
            <a:off x="3202884" y="4140476"/>
            <a:ext cx="6096000" cy="400110"/>
          </a:xfrm>
          <a:prstGeom prst="rect">
            <a:avLst/>
          </a:prstGeom>
        </p:spPr>
        <p:txBody>
          <a:bodyPr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4: Class predictive probability results for individual spectral classes for development 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in order DS01-DS09).</a:t>
            </a:r>
            <a:endParaRPr kumimoji="0" lang="en-GB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61881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</dc:creator>
  <cp:lastModifiedBy>McAinsh, Martin</cp:lastModifiedBy>
  <cp:revision>2</cp:revision>
  <dcterms:created xsi:type="dcterms:W3CDTF">2018-11-19T20:33:10Z</dcterms:created>
  <dcterms:modified xsi:type="dcterms:W3CDTF">2019-05-01T15:37:53Z</dcterms:modified>
</cp:coreProperties>
</file>